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572000" cy="5716588"/>
  <p:notesSz cx="6858000" cy="90789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D85A2-A2D6-4C15-A1C5-F919264F50D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28600" y="228600"/>
            <a:ext cx="4114800" cy="952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28600" y="1333440"/>
            <a:ext cx="411480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28600" y="3303720"/>
            <a:ext cx="411480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85FBAB-E148-4ACE-B348-35B3CF9511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28600" y="228600"/>
            <a:ext cx="4114800" cy="952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28600" y="1333440"/>
            <a:ext cx="200772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337120" y="1333440"/>
            <a:ext cx="200772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28600" y="3303720"/>
            <a:ext cx="200772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337120" y="3303720"/>
            <a:ext cx="200772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9CA5ED-EAA4-4EDD-B646-A3C49ACB4F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28600" y="228600"/>
            <a:ext cx="4114800" cy="952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28600" y="1333440"/>
            <a:ext cx="132480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620000" y="1333440"/>
            <a:ext cx="132480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011400" y="1333440"/>
            <a:ext cx="132480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28600" y="3303720"/>
            <a:ext cx="132480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620000" y="3303720"/>
            <a:ext cx="132480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011400" y="3303720"/>
            <a:ext cx="132480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3BDBFD-576B-498F-A43C-222A813B46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28600" y="228600"/>
            <a:ext cx="4114800" cy="952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28600" y="1333440"/>
            <a:ext cx="4114800" cy="377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24"/>
              </a:spcBef>
              <a:buNone/>
              <a:tabLst>
                <a:tab algn="l" pos="0"/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425028-2113-48D4-BB80-24310384E3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28600" y="228600"/>
            <a:ext cx="4114800" cy="952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28600" y="1333440"/>
            <a:ext cx="4114800" cy="3772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FCCE7-0FDF-431F-AE71-5FE6912A1F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28600" y="228600"/>
            <a:ext cx="4114800" cy="952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28600" y="1333440"/>
            <a:ext cx="2007720" cy="3772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337120" y="1333440"/>
            <a:ext cx="2007720" cy="3772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F88456-9C0B-4014-8941-8F3B47B059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28600" y="228600"/>
            <a:ext cx="4114800" cy="952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61159B-681D-4333-84CB-C4DDBBAA0A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28600" y="228600"/>
            <a:ext cx="4114800" cy="441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24"/>
              </a:spcBef>
              <a:tabLst>
                <a:tab algn="l" pos="0"/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57B01F-B150-4A93-B6BC-D132C414AE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28600" y="228600"/>
            <a:ext cx="4114800" cy="952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28600" y="1333440"/>
            <a:ext cx="200772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337120" y="1333440"/>
            <a:ext cx="2007720" cy="3772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28600" y="3303720"/>
            <a:ext cx="200772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51B0FD-8D20-41F8-974A-E7D831EA0E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28600" y="228600"/>
            <a:ext cx="4114800" cy="952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28600" y="1333440"/>
            <a:ext cx="2007720" cy="3772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337120" y="1333440"/>
            <a:ext cx="200772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337120" y="3303720"/>
            <a:ext cx="200772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D99D36-F6BC-4EAC-812C-6F3FC37378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28600" y="228600"/>
            <a:ext cx="4114800" cy="952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28600" y="1333440"/>
            <a:ext cx="200772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337120" y="1333440"/>
            <a:ext cx="200772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28600" y="3303720"/>
            <a:ext cx="4114800" cy="179892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CF9BEC-FF67-4C00-A53A-D82437D7BD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28600" y="228600"/>
            <a:ext cx="4114800" cy="952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28600" y="1333440"/>
            <a:ext cx="4114800" cy="3772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marL="225360" indent="-22536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488880" indent="-18900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750960" indent="-14940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050840" indent="-15084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351080" indent="-14940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351080" indent="-14940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351080" indent="-14940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28240" y="5204880"/>
            <a:ext cx="1066680" cy="397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562040" y="5204880"/>
            <a:ext cx="1447920" cy="397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276360" y="5204880"/>
            <a:ext cx="1066680" cy="397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Autofit/>
          </a:bodyPr>
          <a:lstStyle>
            <a:lvl1pPr indent="0" algn="r">
              <a:buNone/>
              <a:tabLst>
                <a:tab algn="l" pos="0"/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  <a:defRPr b="0" lang="en-US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601560"/>
                <a:tab algn="l" pos="1203480"/>
                <a:tab algn="l" pos="1805040"/>
                <a:tab algn="l" pos="2406600"/>
                <a:tab algn="l" pos="3008160"/>
                <a:tab algn="l" pos="3610080"/>
                <a:tab algn="l" pos="4211640"/>
                <a:tab algn="l" pos="4813200"/>
                <a:tab algn="l" pos="5415120"/>
                <a:tab algn="l" pos="6016680"/>
                <a:tab algn="l" pos="6618240"/>
                <a:tab algn="l" pos="7219800"/>
                <a:tab algn="l" pos="7821720"/>
                <a:tab algn="l" pos="8423280"/>
                <a:tab algn="l" pos="9024840"/>
                <a:tab algn="l" pos="9626760"/>
                <a:tab algn="l" pos="10228320"/>
                <a:tab algn="l" pos="10829880"/>
              </a:tabLst>
            </a:pPr>
            <a:fld id="{2C34E3C5-83C0-457B-83CD-998941DA44D8}" type="slidenum">
              <a:rPr b="0" lang="en-US" sz="9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png"/><Relationship Id="rId6" Type="http://schemas.openxmlformats.org/officeDocument/2006/relationships/image" Target="../media/image5.png"/><Relationship Id="rId7" Type="http://schemas.openxmlformats.org/officeDocument/2006/relationships/image" Target="../media/image5.png"/><Relationship Id="rId8" Type="http://schemas.openxmlformats.org/officeDocument/2006/relationships/image" Target="../media/image5.png"/><Relationship Id="rId9" Type="http://schemas.openxmlformats.org/officeDocument/2006/relationships/image" Target="../media/image5.png"/><Relationship Id="rId10" Type="http://schemas.openxmlformats.org/officeDocument/2006/relationships/image" Target="../media/image5.png"/><Relationship Id="rId11" Type="http://schemas.openxmlformats.org/officeDocument/2006/relationships/image" Target="../media/image5.png"/><Relationship Id="rId1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9360" y="19080"/>
            <a:ext cx="4573800" cy="5703840"/>
            <a:chOff x="9360" y="19080"/>
            <a:chExt cx="4573800" cy="5703840"/>
          </a:xfrm>
        </p:grpSpPr>
        <p:pic>
          <p:nvPicPr>
            <p:cNvPr id="42" name="Picture 4" descr=""/>
            <p:cNvPicPr/>
            <p:nvPr/>
          </p:nvPicPr>
          <p:blipFill>
            <a:blip r:embed="rId1"/>
            <a:stretch/>
          </p:blipFill>
          <p:spPr>
            <a:xfrm>
              <a:off x="507960" y="936720"/>
              <a:ext cx="1433520" cy="2103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 Box 5"/>
            <p:cNvSpPr/>
            <p:nvPr/>
          </p:nvSpPr>
          <p:spPr>
            <a:xfrm>
              <a:off x="496800" y="25560"/>
              <a:ext cx="1601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VPaI-1 (VP380-VP403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" name="Picture 6" descr=""/>
            <p:cNvPicPr/>
            <p:nvPr/>
          </p:nvPicPr>
          <p:blipFill>
            <a:blip r:embed="rId2"/>
            <a:stretch/>
          </p:blipFill>
          <p:spPr>
            <a:xfrm>
              <a:off x="2227320" y="903240"/>
              <a:ext cx="2319120" cy="2130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Text Box 7"/>
            <p:cNvSpPr/>
            <p:nvPr/>
          </p:nvSpPr>
          <p:spPr>
            <a:xfrm>
              <a:off x="2757240" y="25560"/>
              <a:ext cx="1662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VPaI-4 (VP2131-VP2144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6" name="Picture 9" descr=""/>
            <p:cNvPicPr/>
            <p:nvPr/>
          </p:nvPicPr>
          <p:blipFill>
            <a:blip r:embed="rId3"/>
            <a:stretch/>
          </p:blipFill>
          <p:spPr>
            <a:xfrm>
              <a:off x="415800" y="4059360"/>
              <a:ext cx="2117880" cy="165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Text Box 10"/>
            <p:cNvSpPr/>
            <p:nvPr/>
          </p:nvSpPr>
          <p:spPr>
            <a:xfrm>
              <a:off x="260280" y="3173400"/>
              <a:ext cx="1784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VPaI-5 (VP2900-VP2910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Picture 12" descr=""/>
            <p:cNvPicPr/>
            <p:nvPr/>
          </p:nvPicPr>
          <p:blipFill>
            <a:blip r:embed="rId4"/>
            <a:stretch/>
          </p:blipFill>
          <p:spPr>
            <a:xfrm>
              <a:off x="2641680" y="4035600"/>
              <a:ext cx="1850760" cy="1687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Text Box 13"/>
            <p:cNvSpPr/>
            <p:nvPr/>
          </p:nvSpPr>
          <p:spPr>
            <a:xfrm>
              <a:off x="2712960" y="3192480"/>
              <a:ext cx="164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VPaI-6 (VP1254-VP1270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18"/>
            <p:cNvSpPr/>
            <p:nvPr/>
          </p:nvSpPr>
          <p:spPr>
            <a:xfrm>
              <a:off x="54000" y="527040"/>
              <a:ext cx="220320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Freeform 19"/>
            <p:cNvSpPr/>
            <p:nvPr/>
          </p:nvSpPr>
          <p:spPr>
            <a:xfrm>
              <a:off x="876240" y="407880"/>
              <a:ext cx="88920" cy="2415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20"/>
            <p:cNvSpPr/>
            <p:nvPr/>
          </p:nvSpPr>
          <p:spPr>
            <a:xfrm>
              <a:off x="1244520" y="407880"/>
              <a:ext cx="176040" cy="2415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21"/>
            <p:cNvSpPr/>
            <p:nvPr/>
          </p:nvSpPr>
          <p:spPr>
            <a:xfrm>
              <a:off x="1427040" y="407880"/>
              <a:ext cx="19080" cy="2415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22"/>
            <p:cNvSpPr/>
            <p:nvPr/>
          </p:nvSpPr>
          <p:spPr>
            <a:xfrm>
              <a:off x="1596960" y="406440"/>
              <a:ext cx="15840" cy="2397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23"/>
            <p:cNvSpPr/>
            <p:nvPr/>
          </p:nvSpPr>
          <p:spPr>
            <a:xfrm>
              <a:off x="1482480" y="407880"/>
              <a:ext cx="82800" cy="2415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24"/>
            <p:cNvSpPr/>
            <p:nvPr/>
          </p:nvSpPr>
          <p:spPr>
            <a:xfrm>
              <a:off x="1647720" y="407880"/>
              <a:ext cx="65160" cy="2415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25"/>
            <p:cNvSpPr/>
            <p:nvPr/>
          </p:nvSpPr>
          <p:spPr>
            <a:xfrm>
              <a:off x="1973160" y="407880"/>
              <a:ext cx="106200" cy="2415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8" name="Group 26"/>
            <p:cNvGrpSpPr/>
            <p:nvPr/>
          </p:nvGrpSpPr>
          <p:grpSpPr>
            <a:xfrm>
              <a:off x="2093760" y="407880"/>
              <a:ext cx="17640" cy="241560"/>
              <a:chOff x="2093760" y="407880"/>
              <a:chExt cx="17640" cy="241560"/>
            </a:xfrm>
          </p:grpSpPr>
          <p:sp>
            <p:nvSpPr>
              <p:cNvPr id="59" name="Freeform 27"/>
              <p:cNvSpPr/>
              <p:nvPr/>
            </p:nvSpPr>
            <p:spPr>
              <a:xfrm>
                <a:off x="2093760" y="407880"/>
                <a:ext cx="17640" cy="241560"/>
              </a:xfrm>
              <a:prstGeom prst="pie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Freeform 28"/>
              <p:cNvSpPr/>
              <p:nvPr/>
            </p:nvSpPr>
            <p:spPr>
              <a:xfrm>
                <a:off x="2093760" y="407880"/>
                <a:ext cx="17640" cy="241560"/>
              </a:xfrm>
              <a:prstGeom prst="pie">
                <a:avLst/>
              </a:prstGeom>
              <a:solidFill>
                <a:srgbClr val="ffffff"/>
              </a:solidFill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1" name="Freeform 29"/>
            <p:cNvSpPr/>
            <p:nvPr/>
          </p:nvSpPr>
          <p:spPr>
            <a:xfrm>
              <a:off x="1758960" y="407880"/>
              <a:ext cx="180720" cy="2415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30"/>
            <p:cNvSpPr/>
            <p:nvPr/>
          </p:nvSpPr>
          <p:spPr>
            <a:xfrm>
              <a:off x="755640" y="407880"/>
              <a:ext cx="120600" cy="2415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31"/>
            <p:cNvSpPr/>
            <p:nvPr/>
          </p:nvSpPr>
          <p:spPr>
            <a:xfrm>
              <a:off x="876240" y="407880"/>
              <a:ext cx="88920" cy="2415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Freeform 32"/>
            <p:cNvSpPr/>
            <p:nvPr/>
          </p:nvSpPr>
          <p:spPr>
            <a:xfrm>
              <a:off x="1244520" y="407880"/>
              <a:ext cx="176040" cy="2415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33"/>
            <p:cNvSpPr/>
            <p:nvPr/>
          </p:nvSpPr>
          <p:spPr>
            <a:xfrm>
              <a:off x="1482480" y="407880"/>
              <a:ext cx="82800" cy="2415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34"/>
            <p:cNvSpPr/>
            <p:nvPr/>
          </p:nvSpPr>
          <p:spPr>
            <a:xfrm>
              <a:off x="1973160" y="407880"/>
              <a:ext cx="106200" cy="2415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Freeform 35"/>
            <p:cNvSpPr/>
            <p:nvPr/>
          </p:nvSpPr>
          <p:spPr>
            <a:xfrm>
              <a:off x="1758960" y="407880"/>
              <a:ext cx="180720" cy="2415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36"/>
            <p:cNvSpPr/>
            <p:nvPr/>
          </p:nvSpPr>
          <p:spPr>
            <a:xfrm>
              <a:off x="755640" y="407880"/>
              <a:ext cx="120600" cy="2415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Freeform 37"/>
            <p:cNvSpPr/>
            <p:nvPr/>
          </p:nvSpPr>
          <p:spPr>
            <a:xfrm>
              <a:off x="171360" y="407880"/>
              <a:ext cx="120600" cy="241560"/>
            </a:xfrm>
            <a:prstGeom prst="pie">
              <a:avLst/>
            </a:prstGeom>
            <a:blipFill rotWithShape="0">
              <a:blip r:embed="rId5"/>
              <a:srcRect/>
              <a:tile tx="0" ty="0" sx="100000" sy="100000" algn="ctr"/>
            </a:blip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38"/>
            <p:cNvSpPr/>
            <p:nvPr/>
          </p:nvSpPr>
          <p:spPr>
            <a:xfrm>
              <a:off x="1758960" y="407880"/>
              <a:ext cx="180720" cy="241560"/>
            </a:xfrm>
            <a:prstGeom prst="pie">
              <a:avLst/>
            </a:prstGeom>
            <a:solidFill>
              <a:srgbClr val="ffffff"/>
            </a:solid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39"/>
            <p:cNvSpPr/>
            <p:nvPr/>
          </p:nvSpPr>
          <p:spPr>
            <a:xfrm>
              <a:off x="325440" y="461880"/>
              <a:ext cx="411120" cy="1206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40"/>
            <p:cNvSpPr/>
            <p:nvPr/>
          </p:nvSpPr>
          <p:spPr>
            <a:xfrm>
              <a:off x="982440" y="469800"/>
              <a:ext cx="252360" cy="109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41"/>
            <p:cNvSpPr/>
            <p:nvPr/>
          </p:nvSpPr>
          <p:spPr>
            <a:xfrm>
              <a:off x="2093760" y="198360"/>
              <a:ext cx="538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tR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42"/>
            <p:cNvSpPr/>
            <p:nvPr/>
          </p:nvSpPr>
          <p:spPr>
            <a:xfrm>
              <a:off x="1338120" y="620640"/>
              <a:ext cx="47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lp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43"/>
            <p:cNvSpPr/>
            <p:nvPr/>
          </p:nvSpPr>
          <p:spPr>
            <a:xfrm flipV="1">
              <a:off x="1571400" y="539640"/>
              <a:ext cx="36720" cy="123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44"/>
            <p:cNvSpPr/>
            <p:nvPr/>
          </p:nvSpPr>
          <p:spPr>
            <a:xfrm>
              <a:off x="517320" y="623880"/>
              <a:ext cx="1068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HsdSM Hsd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45"/>
            <p:cNvSpPr/>
            <p:nvPr/>
          </p:nvSpPr>
          <p:spPr>
            <a:xfrm flipV="1">
              <a:off x="668160" y="545760"/>
              <a:ext cx="144720" cy="11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46"/>
            <p:cNvSpPr/>
            <p:nvPr/>
          </p:nvSpPr>
          <p:spPr>
            <a:xfrm flipH="1" flipV="1">
              <a:off x="925200" y="539280"/>
              <a:ext cx="4680" cy="11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47"/>
            <p:cNvSpPr/>
            <p:nvPr/>
          </p:nvSpPr>
          <p:spPr>
            <a:xfrm flipV="1">
              <a:off x="1163520" y="539280"/>
              <a:ext cx="222120" cy="12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48"/>
            <p:cNvSpPr/>
            <p:nvPr/>
          </p:nvSpPr>
          <p:spPr>
            <a:xfrm>
              <a:off x="1662120" y="62388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Y4m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49"/>
            <p:cNvSpPr/>
            <p:nvPr/>
          </p:nvSpPr>
          <p:spPr>
            <a:xfrm flipH="1">
              <a:off x="1838160" y="538200"/>
              <a:ext cx="31680" cy="122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50"/>
            <p:cNvSpPr/>
            <p:nvPr/>
          </p:nvSpPr>
          <p:spPr>
            <a:xfrm>
              <a:off x="46080" y="604800"/>
              <a:ext cx="458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I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51"/>
            <p:cNvSpPr/>
            <p:nvPr/>
          </p:nvSpPr>
          <p:spPr>
            <a:xfrm flipH="1">
              <a:off x="207720" y="552600"/>
              <a:ext cx="7920" cy="102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52"/>
            <p:cNvSpPr/>
            <p:nvPr/>
          </p:nvSpPr>
          <p:spPr>
            <a:xfrm>
              <a:off x="118800" y="466560"/>
              <a:ext cx="36720" cy="1159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53"/>
            <p:cNvSpPr/>
            <p:nvPr/>
          </p:nvSpPr>
          <p:spPr>
            <a:xfrm>
              <a:off x="2124000" y="471600"/>
              <a:ext cx="39600" cy="117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54"/>
            <p:cNvSpPr/>
            <p:nvPr/>
          </p:nvSpPr>
          <p:spPr>
            <a:xfrm>
              <a:off x="2147760" y="471600"/>
              <a:ext cx="41400" cy="11736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55"/>
            <p:cNvSpPr/>
            <p:nvPr/>
          </p:nvSpPr>
          <p:spPr>
            <a:xfrm flipV="1">
              <a:off x="2165400" y="334440"/>
              <a:ext cx="137880" cy="133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56"/>
            <p:cNvSpPr/>
            <p:nvPr/>
          </p:nvSpPr>
          <p:spPr>
            <a:xfrm>
              <a:off x="9360" y="228600"/>
              <a:ext cx="419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57"/>
            <p:cNvSpPr/>
            <p:nvPr/>
          </p:nvSpPr>
          <p:spPr>
            <a:xfrm flipH="1">
              <a:off x="131760" y="361800"/>
              <a:ext cx="31680" cy="147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58"/>
            <p:cNvSpPr/>
            <p:nvPr/>
          </p:nvSpPr>
          <p:spPr>
            <a:xfrm>
              <a:off x="1604880" y="173160"/>
              <a:ext cx="40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59"/>
            <p:cNvSpPr/>
            <p:nvPr/>
          </p:nvSpPr>
          <p:spPr>
            <a:xfrm>
              <a:off x="1900080" y="331920"/>
              <a:ext cx="231840" cy="14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82"/>
            <p:cNvSpPr/>
            <p:nvPr/>
          </p:nvSpPr>
          <p:spPr>
            <a:xfrm>
              <a:off x="387360" y="3686040"/>
              <a:ext cx="126504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AutoShape 83"/>
            <p:cNvSpPr/>
            <p:nvPr/>
          </p:nvSpPr>
          <p:spPr>
            <a:xfrm>
              <a:off x="595080" y="3559320"/>
              <a:ext cx="111240" cy="26172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AutoShape 84"/>
            <p:cNvSpPr/>
            <p:nvPr/>
          </p:nvSpPr>
          <p:spPr>
            <a:xfrm flipH="1">
              <a:off x="1315080" y="3564000"/>
              <a:ext cx="127080" cy="258840"/>
            </a:xfrm>
            <a:prstGeom prst="rightArrow">
              <a:avLst>
                <a:gd name="adj1" fmla="val 50000"/>
                <a:gd name="adj2" fmla="val 25000"/>
              </a:avLst>
            </a:prstGeom>
            <a:blipFill rotWithShape="0">
              <a:blip r:embed="rId6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85"/>
            <p:cNvSpPr/>
            <p:nvPr/>
          </p:nvSpPr>
          <p:spPr>
            <a:xfrm>
              <a:off x="446040" y="3618000"/>
              <a:ext cx="30240" cy="1411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86"/>
            <p:cNvSpPr/>
            <p:nvPr/>
          </p:nvSpPr>
          <p:spPr>
            <a:xfrm>
              <a:off x="1600200" y="3633840"/>
              <a:ext cx="30240" cy="128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87"/>
            <p:cNvSpPr/>
            <p:nvPr/>
          </p:nvSpPr>
          <p:spPr>
            <a:xfrm>
              <a:off x="720720" y="3624120"/>
              <a:ext cx="144360" cy="133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88"/>
            <p:cNvSpPr/>
            <p:nvPr/>
          </p:nvSpPr>
          <p:spPr>
            <a:xfrm>
              <a:off x="1197000" y="3362400"/>
              <a:ext cx="358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I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89"/>
            <p:cNvSpPr/>
            <p:nvPr/>
          </p:nvSpPr>
          <p:spPr>
            <a:xfrm>
              <a:off x="261720" y="3400560"/>
              <a:ext cx="606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90"/>
            <p:cNvSpPr/>
            <p:nvPr/>
          </p:nvSpPr>
          <p:spPr>
            <a:xfrm flipH="1">
              <a:off x="456840" y="3543480"/>
              <a:ext cx="6120" cy="117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91"/>
            <p:cNvSpPr/>
            <p:nvPr/>
          </p:nvSpPr>
          <p:spPr>
            <a:xfrm flipH="1">
              <a:off x="450360" y="3724200"/>
              <a:ext cx="98280" cy="139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92"/>
            <p:cNvSpPr/>
            <p:nvPr/>
          </p:nvSpPr>
          <p:spPr>
            <a:xfrm>
              <a:off x="1404720" y="3489480"/>
              <a:ext cx="3240" cy="171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 Box 93"/>
            <p:cNvSpPr/>
            <p:nvPr/>
          </p:nvSpPr>
          <p:spPr>
            <a:xfrm>
              <a:off x="1592280" y="3386160"/>
              <a:ext cx="40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R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94"/>
            <p:cNvSpPr/>
            <p:nvPr/>
          </p:nvSpPr>
          <p:spPr>
            <a:xfrm flipV="1">
              <a:off x="1611360" y="3521160"/>
              <a:ext cx="131760" cy="131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AutoShape 95"/>
            <p:cNvSpPr/>
            <p:nvPr/>
          </p:nvSpPr>
          <p:spPr>
            <a:xfrm flipH="1">
              <a:off x="495360" y="3552840"/>
              <a:ext cx="79200" cy="2682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AutoShape 96"/>
            <p:cNvSpPr/>
            <p:nvPr/>
          </p:nvSpPr>
          <p:spPr>
            <a:xfrm>
              <a:off x="888840" y="3562200"/>
              <a:ext cx="125640" cy="25416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AutoShape 97"/>
            <p:cNvSpPr/>
            <p:nvPr/>
          </p:nvSpPr>
          <p:spPr>
            <a:xfrm flipH="1">
              <a:off x="1450080" y="3562200"/>
              <a:ext cx="127080" cy="258840"/>
            </a:xfrm>
            <a:prstGeom prst="rightArrow">
              <a:avLst>
                <a:gd name="adj1" fmla="val 50000"/>
                <a:gd name="adj2" fmla="val 25000"/>
              </a:avLst>
            </a:prstGeom>
            <a:blipFill rotWithShape="0">
              <a:blip r:embed="rId7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98"/>
            <p:cNvSpPr/>
            <p:nvPr/>
          </p:nvSpPr>
          <p:spPr>
            <a:xfrm>
              <a:off x="1025280" y="3629160"/>
              <a:ext cx="276480" cy="131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99"/>
            <p:cNvSpPr/>
            <p:nvPr/>
          </p:nvSpPr>
          <p:spPr>
            <a:xfrm flipH="1" flipV="1">
              <a:off x="1407960" y="3494160"/>
              <a:ext cx="108000" cy="15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100"/>
            <p:cNvSpPr/>
            <p:nvPr/>
          </p:nvSpPr>
          <p:spPr>
            <a:xfrm>
              <a:off x="215640" y="3840120"/>
              <a:ext cx="67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P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 Box 101"/>
            <p:cNvSpPr/>
            <p:nvPr/>
          </p:nvSpPr>
          <p:spPr>
            <a:xfrm>
              <a:off x="766800" y="3811680"/>
              <a:ext cx="733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ParB-lik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102"/>
            <p:cNvSpPr/>
            <p:nvPr/>
          </p:nvSpPr>
          <p:spPr>
            <a:xfrm flipV="1">
              <a:off x="480960" y="3714480"/>
              <a:ext cx="482400" cy="182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103"/>
            <p:cNvSpPr/>
            <p:nvPr/>
          </p:nvSpPr>
          <p:spPr>
            <a:xfrm>
              <a:off x="650880" y="3703680"/>
              <a:ext cx="174600" cy="163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105"/>
            <p:cNvSpPr/>
            <p:nvPr/>
          </p:nvSpPr>
          <p:spPr>
            <a:xfrm rot="16200000">
              <a:off x="2660760" y="3654000"/>
              <a:ext cx="183960" cy="24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rot="10800000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106"/>
            <p:cNvSpPr/>
            <p:nvPr/>
          </p:nvSpPr>
          <p:spPr>
            <a:xfrm flipV="1">
              <a:off x="2523960" y="3705120"/>
              <a:ext cx="1882800" cy="504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Freeform 107"/>
            <p:cNvSpPr/>
            <p:nvPr/>
          </p:nvSpPr>
          <p:spPr>
            <a:xfrm>
              <a:off x="2671560" y="3554280"/>
              <a:ext cx="55800" cy="303480"/>
            </a:xfrm>
            <a:prstGeom prst="pie">
              <a:avLst/>
            </a:prstGeom>
            <a:blipFill rotWithShape="0">
              <a:blip r:embed="rId8"/>
              <a:srcRect/>
              <a:tile tx="0" ty="0" sx="100000" sy="100000" algn="ctr"/>
            </a:blip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Freeform 108"/>
            <p:cNvSpPr/>
            <p:nvPr/>
          </p:nvSpPr>
          <p:spPr>
            <a:xfrm flipH="1">
              <a:off x="4044240" y="3556080"/>
              <a:ext cx="29880" cy="304560"/>
            </a:xfrm>
            <a:prstGeom prst="pi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109"/>
            <p:cNvSpPr/>
            <p:nvPr/>
          </p:nvSpPr>
          <p:spPr>
            <a:xfrm>
              <a:off x="4103640" y="3548160"/>
              <a:ext cx="193680" cy="306360"/>
            </a:xfrm>
            <a:prstGeom prst="pie">
              <a:avLst/>
            </a:prstGeom>
            <a:blipFill rotWithShape="0">
              <a:blip r:embed="rId9"/>
              <a:srcRect/>
              <a:tile tx="0" ty="0" sx="100000" sy="100000" algn="ctr"/>
            </a:blip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110"/>
            <p:cNvSpPr/>
            <p:nvPr/>
          </p:nvSpPr>
          <p:spPr>
            <a:xfrm>
              <a:off x="4317840" y="3614760"/>
              <a:ext cx="30240" cy="1699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111"/>
            <p:cNvSpPr/>
            <p:nvPr/>
          </p:nvSpPr>
          <p:spPr>
            <a:xfrm>
              <a:off x="2608200" y="3622680"/>
              <a:ext cx="44280" cy="155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112"/>
            <p:cNvSpPr/>
            <p:nvPr/>
          </p:nvSpPr>
          <p:spPr>
            <a:xfrm>
              <a:off x="4162320" y="3313080"/>
              <a:ext cx="40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113"/>
            <p:cNvSpPr/>
            <p:nvPr/>
          </p:nvSpPr>
          <p:spPr>
            <a:xfrm>
              <a:off x="2751120" y="3381480"/>
              <a:ext cx="469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Tn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114"/>
            <p:cNvSpPr/>
            <p:nvPr/>
          </p:nvSpPr>
          <p:spPr>
            <a:xfrm>
              <a:off x="2469960" y="3378240"/>
              <a:ext cx="433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115"/>
            <p:cNvSpPr/>
            <p:nvPr/>
          </p:nvSpPr>
          <p:spPr>
            <a:xfrm>
              <a:off x="2619360" y="3517920"/>
              <a:ext cx="6120" cy="147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116"/>
            <p:cNvSpPr/>
            <p:nvPr/>
          </p:nvSpPr>
          <p:spPr>
            <a:xfrm flipH="1">
              <a:off x="2693880" y="3519360"/>
              <a:ext cx="169920" cy="157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117"/>
            <p:cNvSpPr/>
            <p:nvPr/>
          </p:nvSpPr>
          <p:spPr>
            <a:xfrm flipH="1" flipV="1">
              <a:off x="4316040" y="3476520"/>
              <a:ext cx="20520" cy="169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118"/>
            <p:cNvSpPr/>
            <p:nvPr/>
          </p:nvSpPr>
          <p:spPr>
            <a:xfrm>
              <a:off x="3556080" y="3795840"/>
              <a:ext cx="64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olic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 Box 119"/>
            <p:cNvSpPr/>
            <p:nvPr/>
          </p:nvSpPr>
          <p:spPr>
            <a:xfrm>
              <a:off x="3854520" y="3319560"/>
              <a:ext cx="363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I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120"/>
            <p:cNvSpPr/>
            <p:nvPr/>
          </p:nvSpPr>
          <p:spPr>
            <a:xfrm flipV="1">
              <a:off x="3811320" y="3749400"/>
              <a:ext cx="236880" cy="122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121"/>
            <p:cNvSpPr/>
            <p:nvPr/>
          </p:nvSpPr>
          <p:spPr>
            <a:xfrm>
              <a:off x="2751120" y="3633840"/>
              <a:ext cx="1270080" cy="141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122"/>
            <p:cNvSpPr/>
            <p:nvPr/>
          </p:nvSpPr>
          <p:spPr>
            <a:xfrm>
              <a:off x="4022640" y="3490920"/>
              <a:ext cx="201600" cy="208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62"/>
            <p:cNvSpPr/>
            <p:nvPr/>
          </p:nvSpPr>
          <p:spPr>
            <a:xfrm>
              <a:off x="2811240" y="603360"/>
              <a:ext cx="1621080" cy="144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AutoShape 63"/>
            <p:cNvSpPr/>
            <p:nvPr/>
          </p:nvSpPr>
          <p:spPr>
            <a:xfrm>
              <a:off x="3054240" y="477720"/>
              <a:ext cx="131760" cy="246240"/>
            </a:xfrm>
            <a:prstGeom prst="rightArrow">
              <a:avLst>
                <a:gd name="adj1" fmla="val 50000"/>
                <a:gd name="adj2" fmla="val 25000"/>
              </a:avLst>
            </a:prstGeom>
            <a:blipFill rotWithShape="0">
              <a:blip r:embed="rId10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AutoShape 64"/>
            <p:cNvSpPr/>
            <p:nvPr/>
          </p:nvSpPr>
          <p:spPr>
            <a:xfrm>
              <a:off x="3465360" y="485640"/>
              <a:ext cx="300240" cy="230400"/>
            </a:xfrm>
            <a:prstGeom prst="rightArrow">
              <a:avLst>
                <a:gd name="adj1" fmla="val 50000"/>
                <a:gd name="adj2" fmla="val 32578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AutoShape 65"/>
            <p:cNvSpPr/>
            <p:nvPr/>
          </p:nvSpPr>
          <p:spPr>
            <a:xfrm>
              <a:off x="3817800" y="482760"/>
              <a:ext cx="165240" cy="234720"/>
            </a:xfrm>
            <a:prstGeom prst="rightArrow">
              <a:avLst>
                <a:gd name="adj1" fmla="val 50000"/>
                <a:gd name="adj2" fmla="val 25000"/>
              </a:avLst>
            </a:prstGeom>
            <a:blipFill rotWithShape="0">
              <a:blip r:embed="rId1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66"/>
            <p:cNvSpPr/>
            <p:nvPr/>
          </p:nvSpPr>
          <p:spPr>
            <a:xfrm>
              <a:off x="2960640" y="534960"/>
              <a:ext cx="44280" cy="12384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67"/>
            <p:cNvSpPr/>
            <p:nvPr/>
          </p:nvSpPr>
          <p:spPr>
            <a:xfrm>
              <a:off x="3004920" y="531720"/>
              <a:ext cx="32040" cy="128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68"/>
            <p:cNvSpPr/>
            <p:nvPr/>
          </p:nvSpPr>
          <p:spPr>
            <a:xfrm>
              <a:off x="4344840" y="546120"/>
              <a:ext cx="33480" cy="117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69"/>
            <p:cNvSpPr/>
            <p:nvPr/>
          </p:nvSpPr>
          <p:spPr>
            <a:xfrm>
              <a:off x="3213000" y="538200"/>
              <a:ext cx="219240" cy="1206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70"/>
            <p:cNvSpPr/>
            <p:nvPr/>
          </p:nvSpPr>
          <p:spPr>
            <a:xfrm>
              <a:off x="4030560" y="538200"/>
              <a:ext cx="289080" cy="125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 Box 71"/>
            <p:cNvSpPr/>
            <p:nvPr/>
          </p:nvSpPr>
          <p:spPr>
            <a:xfrm>
              <a:off x="2573280" y="268200"/>
              <a:ext cx="534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tR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 Box 72"/>
            <p:cNvSpPr/>
            <p:nvPr/>
          </p:nvSpPr>
          <p:spPr>
            <a:xfrm>
              <a:off x="2828880" y="636480"/>
              <a:ext cx="414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I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 Box 73"/>
            <p:cNvSpPr/>
            <p:nvPr/>
          </p:nvSpPr>
          <p:spPr>
            <a:xfrm>
              <a:off x="2984400" y="268200"/>
              <a:ext cx="422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74"/>
            <p:cNvSpPr/>
            <p:nvPr/>
          </p:nvSpPr>
          <p:spPr>
            <a:xfrm>
              <a:off x="3146400" y="466560"/>
              <a:ext cx="4680" cy="95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75"/>
            <p:cNvSpPr/>
            <p:nvPr/>
          </p:nvSpPr>
          <p:spPr>
            <a:xfrm>
              <a:off x="2873160" y="428760"/>
              <a:ext cx="104760" cy="158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76"/>
            <p:cNvSpPr/>
            <p:nvPr/>
          </p:nvSpPr>
          <p:spPr>
            <a:xfrm flipV="1">
              <a:off x="3031920" y="626760"/>
              <a:ext cx="55800" cy="98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 Box 77"/>
            <p:cNvSpPr/>
            <p:nvPr/>
          </p:nvSpPr>
          <p:spPr>
            <a:xfrm>
              <a:off x="3421080" y="262080"/>
              <a:ext cx="7873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ytotoxin I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78"/>
            <p:cNvSpPr/>
            <p:nvPr/>
          </p:nvSpPr>
          <p:spPr>
            <a:xfrm>
              <a:off x="3859200" y="396720"/>
              <a:ext cx="9360" cy="196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Text Box 79"/>
            <p:cNvSpPr/>
            <p:nvPr/>
          </p:nvSpPr>
          <p:spPr>
            <a:xfrm>
              <a:off x="4198680" y="262080"/>
              <a:ext cx="384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80"/>
            <p:cNvSpPr/>
            <p:nvPr/>
          </p:nvSpPr>
          <p:spPr>
            <a:xfrm flipV="1">
              <a:off x="4367160" y="431640"/>
              <a:ext cx="23760" cy="138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123"/>
            <p:cNvSpPr/>
            <p:nvPr/>
          </p:nvSpPr>
          <p:spPr>
            <a:xfrm flipH="1">
              <a:off x="3028320" y="406440"/>
              <a:ext cx="93960" cy="163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128"/>
            <p:cNvSpPr/>
            <p:nvPr/>
          </p:nvSpPr>
          <p:spPr>
            <a:xfrm flipH="1" flipV="1">
              <a:off x="100080" y="560160"/>
              <a:ext cx="892080" cy="54756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129"/>
            <p:cNvSpPr/>
            <p:nvPr/>
          </p:nvSpPr>
          <p:spPr>
            <a:xfrm flipV="1">
              <a:off x="1649160" y="560160"/>
              <a:ext cx="492120" cy="55404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130"/>
            <p:cNvSpPr/>
            <p:nvPr/>
          </p:nvSpPr>
          <p:spPr>
            <a:xfrm flipV="1">
              <a:off x="3004920" y="612360"/>
              <a:ext cx="14400" cy="46836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131"/>
            <p:cNvSpPr/>
            <p:nvPr/>
          </p:nvSpPr>
          <p:spPr>
            <a:xfrm flipV="1">
              <a:off x="3733560" y="593280"/>
              <a:ext cx="635040" cy="50004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132"/>
            <p:cNvSpPr/>
            <p:nvPr/>
          </p:nvSpPr>
          <p:spPr>
            <a:xfrm flipH="1" flipV="1">
              <a:off x="446040" y="3687480"/>
              <a:ext cx="185760" cy="51588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133"/>
            <p:cNvSpPr/>
            <p:nvPr/>
          </p:nvSpPr>
          <p:spPr>
            <a:xfrm flipV="1">
              <a:off x="1255680" y="3701880"/>
              <a:ext cx="345960" cy="50184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134"/>
            <p:cNvSpPr/>
            <p:nvPr/>
          </p:nvSpPr>
          <p:spPr>
            <a:xfrm flipH="1" flipV="1">
              <a:off x="2588760" y="3681360"/>
              <a:ext cx="1111320" cy="50328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135"/>
            <p:cNvSpPr/>
            <p:nvPr/>
          </p:nvSpPr>
          <p:spPr>
            <a:xfrm flipV="1">
              <a:off x="4091040" y="3701880"/>
              <a:ext cx="255600" cy="50832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 Box 136"/>
            <p:cNvSpPr/>
            <p:nvPr/>
          </p:nvSpPr>
          <p:spPr>
            <a:xfrm>
              <a:off x="19080" y="19080"/>
              <a:ext cx="628920" cy="329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A.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RIM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221063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AQ38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.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8-21T14:06:44Z</dcterms:created>
  <dc:creator>E. Fidelma Boyd</dc:creator>
  <dc:description/>
  <dc:language>en-US</dc:language>
  <cp:lastModifiedBy>E. Fidelma Boyd</cp:lastModifiedBy>
  <dcterms:modified xsi:type="dcterms:W3CDTF">2008-06-27T18:50:55Z</dcterms:modified>
  <cp:revision>51</cp:revision>
  <dc:subject/>
  <dc:title>Slide 1</dc:title>
</cp:coreProperties>
</file>